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57" r:id="rId2"/>
  </p:sldIdLst>
  <p:sldSz cx="21031200" cy="338328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31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27" autoAdjust="0"/>
    <p:restoredTop sz="94675"/>
  </p:normalViewPr>
  <p:slideViewPr>
    <p:cSldViewPr snapToGrid="0" snapToObjects="1">
      <p:cViewPr>
        <p:scale>
          <a:sx n="40" d="100"/>
          <a:sy n="40" d="100"/>
        </p:scale>
        <p:origin x="904" y="-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hernandez\Downloads\GPR65_Flow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hernandez\Downloads\GPR65_Flow_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hernandez\Downloads\GPR65_Flow_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hernandez\Downloads\GPR65_Flow_Dat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hernandez\Downloads\GPR65_Flow_Dat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hernandez\Downloads\GPR65_Flow_Dat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aw Data'!$E$18</c:f>
              <c:strCache>
                <c:ptCount val="1"/>
                <c:pt idx="0">
                  <c:v>Annexin V+ CFSElo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7A8-4C04-BEE3-BBB68C484394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7A8-4C04-BEE3-BBB68C484394}"/>
              </c:ext>
            </c:extLst>
          </c:dPt>
          <c:errBars>
            <c:errBarType val="plus"/>
            <c:errValType val="cust"/>
            <c:noEndCap val="0"/>
            <c:plus>
              <c:numRef>
                <c:f>'Raw Data'!$E$22:$E$23</c:f>
                <c:numCache>
                  <c:formatCode>General</c:formatCode>
                  <c:ptCount val="2"/>
                  <c:pt idx="0">
                    <c:v>1.0148891565092222</c:v>
                  </c:pt>
                  <c:pt idx="1">
                    <c:v>2.2869193252058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aw Data'!$D$26:$D$27</c:f>
              <c:numCache>
                <c:formatCode>General</c:formatCode>
                <c:ptCount val="2"/>
              </c:numCache>
            </c:numRef>
          </c:cat>
          <c:val>
            <c:numRef>
              <c:f>'Raw Data'!$E$19:$E$20</c:f>
              <c:numCache>
                <c:formatCode>General</c:formatCode>
                <c:ptCount val="2"/>
                <c:pt idx="0">
                  <c:v>28.2</c:v>
                </c:pt>
                <c:pt idx="1">
                  <c:v>20.5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7A8-4C04-BEE3-BBB68C4843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5719119"/>
        <c:axId val="1525702799"/>
      </c:barChart>
      <c:catAx>
        <c:axId val="152571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702799"/>
        <c:crosses val="autoZero"/>
        <c:auto val="1"/>
        <c:lblAlgn val="ctr"/>
        <c:lblOffset val="100"/>
        <c:noMultiLvlLbl val="0"/>
      </c:catAx>
      <c:valAx>
        <c:axId val="1525702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525719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aw Data'!$F$18</c:f>
              <c:strCache>
                <c:ptCount val="1"/>
                <c:pt idx="0">
                  <c:v>Annexin V- CFSElo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136-4E73-91C3-5C4FB181B32E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136-4E73-91C3-5C4FB181B32E}"/>
              </c:ext>
            </c:extLst>
          </c:dPt>
          <c:errBars>
            <c:errBarType val="plus"/>
            <c:errValType val="cust"/>
            <c:noEndCap val="0"/>
            <c:plus>
              <c:numRef>
                <c:f>'Raw Data'!$E$22:$E$23</c:f>
                <c:numCache>
                  <c:formatCode>General</c:formatCode>
                  <c:ptCount val="2"/>
                  <c:pt idx="0">
                    <c:v>1.0148891565092222</c:v>
                  </c:pt>
                  <c:pt idx="1">
                    <c:v>2.2869193252058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aw Data'!$D$26:$D$27</c:f>
              <c:numCache>
                <c:formatCode>General</c:formatCode>
                <c:ptCount val="2"/>
              </c:numCache>
            </c:numRef>
          </c:cat>
          <c:val>
            <c:numRef>
              <c:f>'Raw Data'!$F$19:$F$20</c:f>
              <c:numCache>
                <c:formatCode>General</c:formatCode>
                <c:ptCount val="2"/>
                <c:pt idx="0">
                  <c:v>39.299999999999997</c:v>
                </c:pt>
                <c:pt idx="1">
                  <c:v>3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136-4E73-91C3-5C4FB181B3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5719119"/>
        <c:axId val="1525702799"/>
      </c:barChart>
      <c:catAx>
        <c:axId val="152571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702799"/>
        <c:crosses val="autoZero"/>
        <c:auto val="1"/>
        <c:lblAlgn val="ctr"/>
        <c:lblOffset val="100"/>
        <c:noMultiLvlLbl val="0"/>
      </c:catAx>
      <c:valAx>
        <c:axId val="1525702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525719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aw Data'!$G$18</c:f>
              <c:strCache>
                <c:ptCount val="1"/>
                <c:pt idx="0">
                  <c:v>Annexin V- CFSEhi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A2-434E-804A-0FA01EEA5321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3A2-434E-804A-0FA01EEA5321}"/>
              </c:ext>
            </c:extLst>
          </c:dPt>
          <c:errBars>
            <c:errBarType val="plus"/>
            <c:errValType val="cust"/>
            <c:noEndCap val="0"/>
            <c:plus>
              <c:numRef>
                <c:f>'Raw Data'!$E$22:$E$23</c:f>
                <c:numCache>
                  <c:formatCode>General</c:formatCode>
                  <c:ptCount val="2"/>
                  <c:pt idx="0">
                    <c:v>1.0148891565092222</c:v>
                  </c:pt>
                  <c:pt idx="1">
                    <c:v>2.2869193252058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aw Data'!$D$26:$D$27</c:f>
              <c:numCache>
                <c:formatCode>General</c:formatCode>
                <c:ptCount val="2"/>
              </c:numCache>
            </c:numRef>
          </c:cat>
          <c:val>
            <c:numRef>
              <c:f>'Raw Data'!$G$19:$G$20</c:f>
              <c:numCache>
                <c:formatCode>General</c:formatCode>
                <c:ptCount val="2"/>
                <c:pt idx="0">
                  <c:v>27.366666666666664</c:v>
                </c:pt>
                <c:pt idx="1">
                  <c:v>42.5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3A2-434E-804A-0FA01EEA53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5719119"/>
        <c:axId val="1525702799"/>
      </c:barChart>
      <c:catAx>
        <c:axId val="152571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702799"/>
        <c:crosses val="autoZero"/>
        <c:auto val="1"/>
        <c:lblAlgn val="ctr"/>
        <c:lblOffset val="100"/>
        <c:noMultiLvlLbl val="0"/>
      </c:catAx>
      <c:valAx>
        <c:axId val="1525702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525719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FSE!$E$18</c:f>
              <c:strCache>
                <c:ptCount val="1"/>
                <c:pt idx="0">
                  <c:v>CFSElo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838-4E38-B83D-4C8E24C4875B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838-4E38-B83D-4C8E24C4875B}"/>
              </c:ext>
            </c:extLst>
          </c:dPt>
          <c:errBars>
            <c:errBarType val="plus"/>
            <c:errValType val="cust"/>
            <c:noEndCap val="0"/>
            <c:plus>
              <c:numRef>
                <c:f>CFSE!$E$22:$E$23</c:f>
                <c:numCache>
                  <c:formatCode>General</c:formatCode>
                  <c:ptCount val="2"/>
                  <c:pt idx="0">
                    <c:v>0.65064070986476985</c:v>
                  </c:pt>
                  <c:pt idx="1">
                    <c:v>0.929157324317755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FSE!$D$26:$D$27</c:f>
              <c:numCache>
                <c:formatCode>General</c:formatCode>
                <c:ptCount val="2"/>
              </c:numCache>
            </c:numRef>
          </c:cat>
          <c:val>
            <c:numRef>
              <c:f>CFSE!$E$19:$E$20</c:f>
              <c:numCache>
                <c:formatCode>General</c:formatCode>
                <c:ptCount val="2"/>
                <c:pt idx="0">
                  <c:v>68.666666666666671</c:v>
                </c:pt>
                <c:pt idx="1">
                  <c:v>56.4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838-4E38-B83D-4C8E24C487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5719119"/>
        <c:axId val="1525702799"/>
      </c:barChart>
      <c:catAx>
        <c:axId val="152571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702799"/>
        <c:crosses val="autoZero"/>
        <c:auto val="1"/>
        <c:lblAlgn val="ctr"/>
        <c:lblOffset val="100"/>
        <c:noMultiLvlLbl val="0"/>
      </c:catAx>
      <c:valAx>
        <c:axId val="1525702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525719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FSE!$F$18</c:f>
              <c:strCache>
                <c:ptCount val="1"/>
                <c:pt idx="0">
                  <c:v>CFSE INT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DEF-4E63-BC14-6A0B97438C0F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DEF-4E63-BC14-6A0B97438C0F}"/>
              </c:ext>
            </c:extLst>
          </c:dPt>
          <c:errBars>
            <c:errBarType val="plus"/>
            <c:errValType val="cust"/>
            <c:noEndCap val="0"/>
            <c:plus>
              <c:numRef>
                <c:f>CFSE!$E$22:$E$23</c:f>
                <c:numCache>
                  <c:formatCode>General</c:formatCode>
                  <c:ptCount val="2"/>
                  <c:pt idx="0">
                    <c:v>0.65064070986476985</c:v>
                  </c:pt>
                  <c:pt idx="1">
                    <c:v>0.929157324317755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FSE!$D$26:$D$27</c:f>
              <c:numCache>
                <c:formatCode>General</c:formatCode>
                <c:ptCount val="2"/>
              </c:numCache>
            </c:numRef>
          </c:cat>
          <c:val>
            <c:numRef>
              <c:f>CFSE!$F$19:$F$20</c:f>
              <c:numCache>
                <c:formatCode>General</c:formatCode>
                <c:ptCount val="2"/>
                <c:pt idx="0">
                  <c:v>25.666666666666668</c:v>
                </c:pt>
                <c:pt idx="1">
                  <c:v>34.2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DEF-4E63-BC14-6A0B97438C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5719119"/>
        <c:axId val="1525702799"/>
      </c:barChart>
      <c:catAx>
        <c:axId val="152571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702799"/>
        <c:crosses val="autoZero"/>
        <c:auto val="1"/>
        <c:lblAlgn val="ctr"/>
        <c:lblOffset val="100"/>
        <c:noMultiLvlLbl val="0"/>
      </c:catAx>
      <c:valAx>
        <c:axId val="1525702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525719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FSE!$G$18</c:f>
              <c:strCache>
                <c:ptCount val="1"/>
                <c:pt idx="0">
                  <c:v> CFSEhi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548-4783-92E5-D9F22A34A919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548-4783-92E5-D9F22A34A919}"/>
              </c:ext>
            </c:extLst>
          </c:dPt>
          <c:errBars>
            <c:errBarType val="plus"/>
            <c:errValType val="cust"/>
            <c:noEndCap val="0"/>
            <c:plus>
              <c:numRef>
                <c:f>CFSE!$E$22:$E$23</c:f>
                <c:numCache>
                  <c:formatCode>General</c:formatCode>
                  <c:ptCount val="2"/>
                  <c:pt idx="0">
                    <c:v>0.65064070986476985</c:v>
                  </c:pt>
                  <c:pt idx="1">
                    <c:v>0.929157324317755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FSE!$D$26:$D$27</c:f>
              <c:numCache>
                <c:formatCode>General</c:formatCode>
                <c:ptCount val="2"/>
              </c:numCache>
            </c:numRef>
          </c:cat>
          <c:val>
            <c:numRef>
              <c:f>CFSE!$G$19:$G$20</c:f>
              <c:numCache>
                <c:formatCode>General</c:formatCode>
                <c:ptCount val="2"/>
                <c:pt idx="0">
                  <c:v>5.666666666666667</c:v>
                </c:pt>
                <c:pt idx="1">
                  <c:v>9.26666666666666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548-4783-92E5-D9F22A34A9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5719119"/>
        <c:axId val="1525702799"/>
      </c:barChart>
      <c:catAx>
        <c:axId val="152571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702799"/>
        <c:crosses val="autoZero"/>
        <c:auto val="1"/>
        <c:lblAlgn val="ctr"/>
        <c:lblOffset val="100"/>
        <c:noMultiLvlLbl val="0"/>
      </c:catAx>
      <c:valAx>
        <c:axId val="1525702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525719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7340" y="5536991"/>
            <a:ext cx="17876520" cy="11778827"/>
          </a:xfrm>
        </p:spPr>
        <p:txBody>
          <a:bodyPr anchor="b"/>
          <a:lstStyle>
            <a:lvl1pPr algn="ctr">
              <a:defRPr sz="13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28900" y="17770054"/>
            <a:ext cx="15773400" cy="8168426"/>
          </a:xfrm>
        </p:spPr>
        <p:txBody>
          <a:bodyPr/>
          <a:lstStyle>
            <a:lvl1pPr marL="0" indent="0" algn="ctr">
              <a:buNone/>
              <a:defRPr sz="5520"/>
            </a:lvl1pPr>
            <a:lvl2pPr marL="1051560" indent="0" algn="ctr">
              <a:buNone/>
              <a:defRPr sz="4600"/>
            </a:lvl2pPr>
            <a:lvl3pPr marL="2103120" indent="0" algn="ctr">
              <a:buNone/>
              <a:defRPr sz="4140"/>
            </a:lvl3pPr>
            <a:lvl4pPr marL="3154680" indent="0" algn="ctr">
              <a:buNone/>
              <a:defRPr sz="3680"/>
            </a:lvl4pPr>
            <a:lvl5pPr marL="4206240" indent="0" algn="ctr">
              <a:buNone/>
              <a:defRPr sz="3680"/>
            </a:lvl5pPr>
            <a:lvl6pPr marL="5257800" indent="0" algn="ctr">
              <a:buNone/>
              <a:defRPr sz="3680"/>
            </a:lvl6pPr>
            <a:lvl7pPr marL="6309360" indent="0" algn="ctr">
              <a:buNone/>
              <a:defRPr sz="3680"/>
            </a:lvl7pPr>
            <a:lvl8pPr marL="7360920" indent="0" algn="ctr">
              <a:buNone/>
              <a:defRPr sz="3680"/>
            </a:lvl8pPr>
            <a:lvl9pPr marL="8412480" indent="0" algn="ctr">
              <a:buNone/>
              <a:defRPr sz="3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5531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663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050453" y="1801283"/>
            <a:ext cx="4534853" cy="28671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45896" y="1801283"/>
            <a:ext cx="13341668" cy="28671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9926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9340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4942" y="8434715"/>
            <a:ext cx="18139410" cy="14073503"/>
          </a:xfrm>
        </p:spPr>
        <p:txBody>
          <a:bodyPr anchor="b"/>
          <a:lstStyle>
            <a:lvl1pPr>
              <a:defRPr sz="13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34942" y="22641358"/>
            <a:ext cx="18139410" cy="7400923"/>
          </a:xfrm>
        </p:spPr>
        <p:txBody>
          <a:bodyPr/>
          <a:lstStyle>
            <a:lvl1pPr marL="0" indent="0">
              <a:buNone/>
              <a:defRPr sz="5520">
                <a:solidFill>
                  <a:schemeClr val="tx1"/>
                </a:solidFill>
              </a:defRPr>
            </a:lvl1pPr>
            <a:lvl2pPr marL="1051560" indent="0">
              <a:buNone/>
              <a:defRPr sz="4600">
                <a:solidFill>
                  <a:schemeClr val="tx1">
                    <a:tint val="75000"/>
                  </a:schemeClr>
                </a:solidFill>
              </a:defRPr>
            </a:lvl2pPr>
            <a:lvl3pPr marL="2103120" indent="0">
              <a:buNone/>
              <a:defRPr sz="4140">
                <a:solidFill>
                  <a:schemeClr val="tx1">
                    <a:tint val="75000"/>
                  </a:schemeClr>
                </a:solidFill>
              </a:defRPr>
            </a:lvl3pPr>
            <a:lvl4pPr marL="315468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4pPr>
            <a:lvl5pPr marL="420624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5pPr>
            <a:lvl6pPr marL="525780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6pPr>
            <a:lvl7pPr marL="630936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7pPr>
            <a:lvl8pPr marL="736092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8pPr>
            <a:lvl9pPr marL="841248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433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45895" y="9006417"/>
            <a:ext cx="8938260" cy="214666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47045" y="9006417"/>
            <a:ext cx="8938260" cy="214666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296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4" y="1801291"/>
            <a:ext cx="18139410" cy="653944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8637" y="8293737"/>
            <a:ext cx="8897182" cy="4064633"/>
          </a:xfrm>
        </p:spPr>
        <p:txBody>
          <a:bodyPr anchor="b"/>
          <a:lstStyle>
            <a:lvl1pPr marL="0" indent="0">
              <a:buNone/>
              <a:defRPr sz="5520" b="1"/>
            </a:lvl1pPr>
            <a:lvl2pPr marL="1051560" indent="0">
              <a:buNone/>
              <a:defRPr sz="4600" b="1"/>
            </a:lvl2pPr>
            <a:lvl3pPr marL="2103120" indent="0">
              <a:buNone/>
              <a:defRPr sz="4140" b="1"/>
            </a:lvl3pPr>
            <a:lvl4pPr marL="3154680" indent="0">
              <a:buNone/>
              <a:defRPr sz="3680" b="1"/>
            </a:lvl4pPr>
            <a:lvl5pPr marL="4206240" indent="0">
              <a:buNone/>
              <a:defRPr sz="3680" b="1"/>
            </a:lvl5pPr>
            <a:lvl6pPr marL="5257800" indent="0">
              <a:buNone/>
              <a:defRPr sz="3680" b="1"/>
            </a:lvl6pPr>
            <a:lvl7pPr marL="6309360" indent="0">
              <a:buNone/>
              <a:defRPr sz="3680" b="1"/>
            </a:lvl7pPr>
            <a:lvl8pPr marL="7360920" indent="0">
              <a:buNone/>
              <a:defRPr sz="3680" b="1"/>
            </a:lvl8pPr>
            <a:lvl9pPr marL="8412480" indent="0">
              <a:buNone/>
              <a:defRPr sz="3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8637" y="12358370"/>
            <a:ext cx="8897182" cy="181773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647046" y="8293737"/>
            <a:ext cx="8940999" cy="4064633"/>
          </a:xfrm>
        </p:spPr>
        <p:txBody>
          <a:bodyPr anchor="b"/>
          <a:lstStyle>
            <a:lvl1pPr marL="0" indent="0">
              <a:buNone/>
              <a:defRPr sz="5520" b="1"/>
            </a:lvl1pPr>
            <a:lvl2pPr marL="1051560" indent="0">
              <a:buNone/>
              <a:defRPr sz="4600" b="1"/>
            </a:lvl2pPr>
            <a:lvl3pPr marL="2103120" indent="0">
              <a:buNone/>
              <a:defRPr sz="4140" b="1"/>
            </a:lvl3pPr>
            <a:lvl4pPr marL="3154680" indent="0">
              <a:buNone/>
              <a:defRPr sz="3680" b="1"/>
            </a:lvl4pPr>
            <a:lvl5pPr marL="4206240" indent="0">
              <a:buNone/>
              <a:defRPr sz="3680" b="1"/>
            </a:lvl5pPr>
            <a:lvl6pPr marL="5257800" indent="0">
              <a:buNone/>
              <a:defRPr sz="3680" b="1"/>
            </a:lvl6pPr>
            <a:lvl7pPr marL="6309360" indent="0">
              <a:buNone/>
              <a:defRPr sz="3680" b="1"/>
            </a:lvl7pPr>
            <a:lvl8pPr marL="7360920" indent="0">
              <a:buNone/>
              <a:defRPr sz="3680" b="1"/>
            </a:lvl8pPr>
            <a:lvl9pPr marL="8412480" indent="0">
              <a:buNone/>
              <a:defRPr sz="3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647046" y="12358370"/>
            <a:ext cx="8940999" cy="181773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2496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4454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4857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5" y="2255520"/>
            <a:ext cx="6783109" cy="7894320"/>
          </a:xfrm>
        </p:spPr>
        <p:txBody>
          <a:bodyPr anchor="b"/>
          <a:lstStyle>
            <a:lvl1pPr>
              <a:defRPr sz="7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40999" y="4871304"/>
            <a:ext cx="10647045" cy="24043217"/>
          </a:xfrm>
        </p:spPr>
        <p:txBody>
          <a:bodyPr/>
          <a:lstStyle>
            <a:lvl1pPr>
              <a:defRPr sz="7360"/>
            </a:lvl1pPr>
            <a:lvl2pPr>
              <a:defRPr sz="6440"/>
            </a:lvl2pPr>
            <a:lvl3pPr>
              <a:defRPr sz="5520"/>
            </a:lvl3pPr>
            <a:lvl4pPr>
              <a:defRPr sz="4600"/>
            </a:lvl4pPr>
            <a:lvl5pPr>
              <a:defRPr sz="4600"/>
            </a:lvl5pPr>
            <a:lvl6pPr>
              <a:defRPr sz="4600"/>
            </a:lvl6pPr>
            <a:lvl7pPr>
              <a:defRPr sz="4600"/>
            </a:lvl7pPr>
            <a:lvl8pPr>
              <a:defRPr sz="4600"/>
            </a:lvl8pPr>
            <a:lvl9pPr>
              <a:defRPr sz="4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8635" y="10149840"/>
            <a:ext cx="6783109" cy="18803834"/>
          </a:xfrm>
        </p:spPr>
        <p:txBody>
          <a:bodyPr/>
          <a:lstStyle>
            <a:lvl1pPr marL="0" indent="0">
              <a:buNone/>
              <a:defRPr sz="3680"/>
            </a:lvl1pPr>
            <a:lvl2pPr marL="1051560" indent="0">
              <a:buNone/>
              <a:defRPr sz="3220"/>
            </a:lvl2pPr>
            <a:lvl3pPr marL="2103120" indent="0">
              <a:buNone/>
              <a:defRPr sz="2760"/>
            </a:lvl3pPr>
            <a:lvl4pPr marL="3154680" indent="0">
              <a:buNone/>
              <a:defRPr sz="2300"/>
            </a:lvl4pPr>
            <a:lvl5pPr marL="4206240" indent="0">
              <a:buNone/>
              <a:defRPr sz="2300"/>
            </a:lvl5pPr>
            <a:lvl6pPr marL="5257800" indent="0">
              <a:buNone/>
              <a:defRPr sz="2300"/>
            </a:lvl6pPr>
            <a:lvl7pPr marL="6309360" indent="0">
              <a:buNone/>
              <a:defRPr sz="2300"/>
            </a:lvl7pPr>
            <a:lvl8pPr marL="7360920" indent="0">
              <a:buNone/>
              <a:defRPr sz="2300"/>
            </a:lvl8pPr>
            <a:lvl9pPr marL="8412480" indent="0">
              <a:buNone/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7753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5" y="2255520"/>
            <a:ext cx="6783109" cy="7894320"/>
          </a:xfrm>
        </p:spPr>
        <p:txBody>
          <a:bodyPr anchor="b"/>
          <a:lstStyle>
            <a:lvl1pPr>
              <a:defRPr sz="7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940999" y="4871304"/>
            <a:ext cx="10647045" cy="24043217"/>
          </a:xfrm>
        </p:spPr>
        <p:txBody>
          <a:bodyPr anchor="t"/>
          <a:lstStyle>
            <a:lvl1pPr marL="0" indent="0">
              <a:buNone/>
              <a:defRPr sz="7360"/>
            </a:lvl1pPr>
            <a:lvl2pPr marL="1051560" indent="0">
              <a:buNone/>
              <a:defRPr sz="6440"/>
            </a:lvl2pPr>
            <a:lvl3pPr marL="2103120" indent="0">
              <a:buNone/>
              <a:defRPr sz="5520"/>
            </a:lvl3pPr>
            <a:lvl4pPr marL="3154680" indent="0">
              <a:buNone/>
              <a:defRPr sz="4600"/>
            </a:lvl4pPr>
            <a:lvl5pPr marL="4206240" indent="0">
              <a:buNone/>
              <a:defRPr sz="4600"/>
            </a:lvl5pPr>
            <a:lvl6pPr marL="5257800" indent="0">
              <a:buNone/>
              <a:defRPr sz="4600"/>
            </a:lvl6pPr>
            <a:lvl7pPr marL="6309360" indent="0">
              <a:buNone/>
              <a:defRPr sz="4600"/>
            </a:lvl7pPr>
            <a:lvl8pPr marL="7360920" indent="0">
              <a:buNone/>
              <a:defRPr sz="4600"/>
            </a:lvl8pPr>
            <a:lvl9pPr marL="8412480" indent="0">
              <a:buNone/>
              <a:defRPr sz="4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8635" y="10149840"/>
            <a:ext cx="6783109" cy="18803834"/>
          </a:xfrm>
        </p:spPr>
        <p:txBody>
          <a:bodyPr/>
          <a:lstStyle>
            <a:lvl1pPr marL="0" indent="0">
              <a:buNone/>
              <a:defRPr sz="3680"/>
            </a:lvl1pPr>
            <a:lvl2pPr marL="1051560" indent="0">
              <a:buNone/>
              <a:defRPr sz="3220"/>
            </a:lvl2pPr>
            <a:lvl3pPr marL="2103120" indent="0">
              <a:buNone/>
              <a:defRPr sz="2760"/>
            </a:lvl3pPr>
            <a:lvl4pPr marL="3154680" indent="0">
              <a:buNone/>
              <a:defRPr sz="2300"/>
            </a:lvl4pPr>
            <a:lvl5pPr marL="4206240" indent="0">
              <a:buNone/>
              <a:defRPr sz="2300"/>
            </a:lvl5pPr>
            <a:lvl6pPr marL="5257800" indent="0">
              <a:buNone/>
              <a:defRPr sz="2300"/>
            </a:lvl6pPr>
            <a:lvl7pPr marL="6309360" indent="0">
              <a:buNone/>
              <a:defRPr sz="2300"/>
            </a:lvl7pPr>
            <a:lvl8pPr marL="7360920" indent="0">
              <a:buNone/>
              <a:defRPr sz="2300"/>
            </a:lvl8pPr>
            <a:lvl9pPr marL="8412480" indent="0">
              <a:buNone/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967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45895" y="1801291"/>
            <a:ext cx="18139410" cy="65394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5895" y="9006417"/>
            <a:ext cx="18139410" cy="214666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45895" y="31358001"/>
            <a:ext cx="4732020" cy="18012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966585" y="31358001"/>
            <a:ext cx="7098030" cy="18012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853285" y="31358001"/>
            <a:ext cx="4732020" cy="18012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772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103120" rtl="0" eaLnBrk="1" latinLnBrk="0" hangingPunct="1">
        <a:lnSpc>
          <a:spcPct val="90000"/>
        </a:lnSpc>
        <a:spcBef>
          <a:spcPct val="0"/>
        </a:spcBef>
        <a:buNone/>
        <a:defRPr sz="101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5780" indent="-525780" algn="l" defTabSz="2103120" rtl="0" eaLnBrk="1" latinLnBrk="0" hangingPunct="1">
        <a:lnSpc>
          <a:spcPct val="90000"/>
        </a:lnSpc>
        <a:spcBef>
          <a:spcPts val="2300"/>
        </a:spcBef>
        <a:buFont typeface="Arial" panose="020B0604020202020204" pitchFamily="34" charset="0"/>
        <a:buChar char="•"/>
        <a:defRPr sz="6440" kern="1200">
          <a:solidFill>
            <a:schemeClr val="tx1"/>
          </a:solidFill>
          <a:latin typeface="+mn-lt"/>
          <a:ea typeface="+mn-ea"/>
          <a:cs typeface="+mn-cs"/>
        </a:defRPr>
      </a:lvl1pPr>
      <a:lvl2pPr marL="157734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5520" kern="1200">
          <a:solidFill>
            <a:schemeClr val="tx1"/>
          </a:solidFill>
          <a:latin typeface="+mn-lt"/>
          <a:ea typeface="+mn-ea"/>
          <a:cs typeface="+mn-cs"/>
        </a:defRPr>
      </a:lvl2pPr>
      <a:lvl3pPr marL="262890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3pPr>
      <a:lvl4pPr marL="368046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4pPr>
      <a:lvl5pPr marL="473202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5pPr>
      <a:lvl6pPr marL="578358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6pPr>
      <a:lvl7pPr marL="683514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7pPr>
      <a:lvl8pPr marL="788670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8pPr>
      <a:lvl9pPr marL="893826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1pPr>
      <a:lvl2pPr marL="105156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2pPr>
      <a:lvl3pPr marL="210312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3pPr>
      <a:lvl4pPr marL="315468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4pPr>
      <a:lvl5pPr marL="420624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5pPr>
      <a:lvl6pPr marL="525780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6pPr>
      <a:lvl7pPr marL="630936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7pPr>
      <a:lvl8pPr marL="736092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8pPr>
      <a:lvl9pPr marL="841248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9859731-A793-15B7-8E15-676F68B7C459}"/>
              </a:ext>
            </a:extLst>
          </p:cNvPr>
          <p:cNvSpPr txBox="1"/>
          <p:nvPr/>
        </p:nvSpPr>
        <p:spPr>
          <a:xfrm>
            <a:off x="764221" y="1661275"/>
            <a:ext cx="5591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0D78A5E-E02D-B169-AA0E-0A7B87884F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3559249"/>
              </p:ext>
            </p:extLst>
          </p:nvPr>
        </p:nvGraphicFramePr>
        <p:xfrm>
          <a:off x="2360763" y="518012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82976A11-0DFD-4DB5-86A1-3A4947E9DF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7736674"/>
              </p:ext>
            </p:extLst>
          </p:nvPr>
        </p:nvGraphicFramePr>
        <p:xfrm>
          <a:off x="7890358" y="524761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7B69F429-3A61-4FC1-99F7-97253464AE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5676045"/>
              </p:ext>
            </p:extLst>
          </p:nvPr>
        </p:nvGraphicFramePr>
        <p:xfrm>
          <a:off x="13470753" y="521822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8" name="Group 7">
            <a:extLst>
              <a:ext uri="{FF2B5EF4-FFF2-40B4-BE49-F238E27FC236}">
                <a16:creationId xmlns:a16="http://schemas.microsoft.com/office/drawing/2014/main" id="{33BDA495-BCAF-9123-7B40-BCDFEBE36DB5}"/>
              </a:ext>
            </a:extLst>
          </p:cNvPr>
          <p:cNvGrpSpPr/>
          <p:nvPr/>
        </p:nvGrpSpPr>
        <p:grpSpPr>
          <a:xfrm>
            <a:off x="17593381" y="3334212"/>
            <a:ext cx="2911057" cy="1020956"/>
            <a:chOff x="17294159" y="2779232"/>
            <a:chExt cx="2911057" cy="1020956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B20F64F-5877-9F2E-5C40-D3BA6B6D8508}"/>
                </a:ext>
              </a:extLst>
            </p:cNvPr>
            <p:cNvSpPr txBox="1"/>
            <p:nvPr/>
          </p:nvSpPr>
          <p:spPr>
            <a:xfrm>
              <a:off x="17690399" y="2779232"/>
              <a:ext cx="251481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PR65</a:t>
              </a:r>
              <a:r>
                <a:rPr lang="ca-ES" sz="24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+/+</a:t>
              </a:r>
              <a:endParaRPr lang="en-US" sz="2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4ABC82A-7A56-CC3C-5727-5ADED522A473}"/>
                </a:ext>
              </a:extLst>
            </p:cNvPr>
            <p:cNvSpPr txBox="1"/>
            <p:nvPr/>
          </p:nvSpPr>
          <p:spPr>
            <a:xfrm>
              <a:off x="17726294" y="3338523"/>
              <a:ext cx="14374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PR65</a:t>
              </a:r>
              <a:r>
                <a:rPr lang="ca-ES" sz="24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-/-</a:t>
              </a:r>
              <a:endParaRPr lang="en-US" sz="2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A7F212F-A4F6-693D-FC56-AC0E7C21AE25}"/>
                </a:ext>
              </a:extLst>
            </p:cNvPr>
            <p:cNvSpPr/>
            <p:nvPr/>
          </p:nvSpPr>
          <p:spPr>
            <a:xfrm>
              <a:off x="17294161" y="3427148"/>
              <a:ext cx="381893" cy="25543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461F589-06C8-4FD1-F1BE-8037FD2F4747}"/>
                </a:ext>
              </a:extLst>
            </p:cNvPr>
            <p:cNvSpPr/>
            <p:nvPr/>
          </p:nvSpPr>
          <p:spPr>
            <a:xfrm>
              <a:off x="17294159" y="2864879"/>
              <a:ext cx="381893" cy="255433"/>
            </a:xfrm>
            <a:prstGeom prst="rect">
              <a:avLst/>
            </a:prstGeom>
            <a:solidFill>
              <a:srgbClr val="0331FF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5D7DA01C-7363-29AA-C9B3-275436DBAD4A}"/>
              </a:ext>
            </a:extLst>
          </p:cNvPr>
          <p:cNvSpPr txBox="1">
            <a:spLocks/>
          </p:cNvSpPr>
          <p:nvPr/>
        </p:nvSpPr>
        <p:spPr>
          <a:xfrm rot="16200000">
            <a:off x="650535" y="10456862"/>
            <a:ext cx="3243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/>
              </a:rPr>
              <a:t>%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endParaRPr lang="en-US" sz="2400" baseline="30000" dirty="0">
              <a:latin typeface="Times New Roman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80EE33B-2B77-4AD8-2D75-AC86AFEA4FA8}"/>
              </a:ext>
            </a:extLst>
          </p:cNvPr>
          <p:cNvSpPr txBox="1">
            <a:spLocks/>
          </p:cNvSpPr>
          <p:nvPr/>
        </p:nvSpPr>
        <p:spPr>
          <a:xfrm rot="16200000">
            <a:off x="6143451" y="6087397"/>
            <a:ext cx="3243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/>
              </a:rPr>
              <a:t>%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V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80EA9F-22D2-E38B-D004-EC72C3C26F75}"/>
              </a:ext>
            </a:extLst>
          </p:cNvPr>
          <p:cNvSpPr txBox="1">
            <a:spLocks/>
          </p:cNvSpPr>
          <p:nvPr/>
        </p:nvSpPr>
        <p:spPr>
          <a:xfrm rot="16200000">
            <a:off x="11687313" y="6087397"/>
            <a:ext cx="3243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/>
              </a:rPr>
              <a:t>%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V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C3A8B9B-5387-B334-BB08-8CED5EA3E20C}"/>
              </a:ext>
            </a:extLst>
          </p:cNvPr>
          <p:cNvCxnSpPr>
            <a:cxnSpLocks/>
          </p:cNvCxnSpPr>
          <p:nvPr/>
        </p:nvCxnSpPr>
        <p:spPr>
          <a:xfrm>
            <a:off x="3953099" y="53498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8F4E5F2-1684-14D4-A759-1FC3C9BCE7A2}"/>
              </a:ext>
            </a:extLst>
          </p:cNvPr>
          <p:cNvCxnSpPr>
            <a:cxnSpLocks/>
          </p:cNvCxnSpPr>
          <p:nvPr/>
        </p:nvCxnSpPr>
        <p:spPr>
          <a:xfrm flipH="1">
            <a:off x="3953107" y="5349838"/>
            <a:ext cx="1935160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78F739A-050E-B414-33F6-A7C6FB083299}"/>
              </a:ext>
            </a:extLst>
          </p:cNvPr>
          <p:cNvSpPr txBox="1">
            <a:spLocks/>
          </p:cNvSpPr>
          <p:nvPr/>
        </p:nvSpPr>
        <p:spPr>
          <a:xfrm>
            <a:off x="3953102" y="4924464"/>
            <a:ext cx="1935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Times New Roman"/>
              </a:rPr>
              <a:t>*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71619C7-4A71-401F-02C8-587B69E3C494}"/>
              </a:ext>
            </a:extLst>
          </p:cNvPr>
          <p:cNvCxnSpPr>
            <a:cxnSpLocks/>
          </p:cNvCxnSpPr>
          <p:nvPr/>
        </p:nvCxnSpPr>
        <p:spPr>
          <a:xfrm>
            <a:off x="5900959" y="53498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22248E3-F74A-E3C9-8391-29E9754802A9}"/>
              </a:ext>
            </a:extLst>
          </p:cNvPr>
          <p:cNvCxnSpPr>
            <a:cxnSpLocks/>
          </p:cNvCxnSpPr>
          <p:nvPr/>
        </p:nvCxnSpPr>
        <p:spPr>
          <a:xfrm>
            <a:off x="9490299" y="53498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C286F8C-69B7-0D9E-B85C-A1BECE1DD8BD}"/>
              </a:ext>
            </a:extLst>
          </p:cNvPr>
          <p:cNvCxnSpPr>
            <a:cxnSpLocks/>
          </p:cNvCxnSpPr>
          <p:nvPr/>
        </p:nvCxnSpPr>
        <p:spPr>
          <a:xfrm flipH="1">
            <a:off x="9490307" y="5349838"/>
            <a:ext cx="1935160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DAAA805-5629-F327-FF22-113B41695236}"/>
              </a:ext>
            </a:extLst>
          </p:cNvPr>
          <p:cNvSpPr txBox="1">
            <a:spLocks/>
          </p:cNvSpPr>
          <p:nvPr/>
        </p:nvSpPr>
        <p:spPr>
          <a:xfrm>
            <a:off x="9490302" y="4924464"/>
            <a:ext cx="1935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Times New Roman"/>
              </a:rPr>
              <a:t>*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D067671-FD1D-A948-631E-116AAEFC2683}"/>
              </a:ext>
            </a:extLst>
          </p:cNvPr>
          <p:cNvCxnSpPr>
            <a:cxnSpLocks/>
          </p:cNvCxnSpPr>
          <p:nvPr/>
        </p:nvCxnSpPr>
        <p:spPr>
          <a:xfrm>
            <a:off x="11425459" y="53498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C68E37C-0947-7B39-ADA2-52B463453D5A}"/>
              </a:ext>
            </a:extLst>
          </p:cNvPr>
          <p:cNvCxnSpPr>
            <a:cxnSpLocks/>
          </p:cNvCxnSpPr>
          <p:nvPr/>
        </p:nvCxnSpPr>
        <p:spPr>
          <a:xfrm>
            <a:off x="15040199" y="53244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1D70CDF8-B8FA-B461-F752-33B43B1F6AC1}"/>
              </a:ext>
            </a:extLst>
          </p:cNvPr>
          <p:cNvCxnSpPr>
            <a:cxnSpLocks/>
          </p:cNvCxnSpPr>
          <p:nvPr/>
        </p:nvCxnSpPr>
        <p:spPr>
          <a:xfrm flipH="1">
            <a:off x="15040207" y="5324438"/>
            <a:ext cx="1935160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94F8870-9651-7AC5-6AA1-532FE6D38F0B}"/>
              </a:ext>
            </a:extLst>
          </p:cNvPr>
          <p:cNvSpPr txBox="1">
            <a:spLocks/>
          </p:cNvSpPr>
          <p:nvPr/>
        </p:nvSpPr>
        <p:spPr>
          <a:xfrm>
            <a:off x="15040202" y="4899064"/>
            <a:ext cx="1935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Times New Roman"/>
              </a:rPr>
              <a:t>**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29B98EEF-6090-0962-4684-C39868DC5011}"/>
              </a:ext>
            </a:extLst>
          </p:cNvPr>
          <p:cNvCxnSpPr>
            <a:cxnSpLocks/>
          </p:cNvCxnSpPr>
          <p:nvPr/>
        </p:nvCxnSpPr>
        <p:spPr>
          <a:xfrm>
            <a:off x="16975359" y="53244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A76219B-F1BE-0035-91A9-C4FA3BE0AB3D}"/>
              </a:ext>
            </a:extLst>
          </p:cNvPr>
          <p:cNvSpPr txBox="1"/>
          <p:nvPr/>
        </p:nvSpPr>
        <p:spPr>
          <a:xfrm>
            <a:off x="1174673" y="4244920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7920FD4-B00C-20A4-1A2B-08D56E08FC31}"/>
              </a:ext>
            </a:extLst>
          </p:cNvPr>
          <p:cNvSpPr txBox="1"/>
          <p:nvPr/>
        </p:nvSpPr>
        <p:spPr>
          <a:xfrm>
            <a:off x="6865791" y="4355168"/>
            <a:ext cx="71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E7CC66-4C0C-A98B-91B1-6FC7C57F32D3}"/>
              </a:ext>
            </a:extLst>
          </p:cNvPr>
          <p:cNvSpPr txBox="1"/>
          <p:nvPr/>
        </p:nvSpPr>
        <p:spPr>
          <a:xfrm>
            <a:off x="12436958" y="4355168"/>
            <a:ext cx="71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C</a:t>
            </a:r>
          </a:p>
        </p:txBody>
      </p:sp>
      <p:graphicFrame>
        <p:nvGraphicFramePr>
          <p:cNvPr id="31" name="Chart 30">
            <a:extLst>
              <a:ext uri="{FF2B5EF4-FFF2-40B4-BE49-F238E27FC236}">
                <a16:creationId xmlns:a16="http://schemas.microsoft.com/office/drawing/2014/main" id="{AA6F7C93-358B-469F-A77C-FA26B89B39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6846863"/>
              </p:ext>
            </p:extLst>
          </p:nvPr>
        </p:nvGraphicFramePr>
        <p:xfrm>
          <a:off x="2474912" y="1025525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239F2302-986C-4E27-B8F4-1F31CCC437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5319793"/>
              </p:ext>
            </p:extLst>
          </p:nvPr>
        </p:nvGraphicFramePr>
        <p:xfrm>
          <a:off x="7879262" y="1023910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3" name="Chart 32">
            <a:extLst>
              <a:ext uri="{FF2B5EF4-FFF2-40B4-BE49-F238E27FC236}">
                <a16:creationId xmlns:a16="http://schemas.microsoft.com/office/drawing/2014/main" id="{1903BFF7-2F59-4187-AB68-B2DDC88330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1072837"/>
              </p:ext>
            </p:extLst>
          </p:nvPr>
        </p:nvGraphicFramePr>
        <p:xfrm>
          <a:off x="13420402" y="102901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816155EE-2342-5FFD-DCB4-D600AC3CBA3F}"/>
              </a:ext>
            </a:extLst>
          </p:cNvPr>
          <p:cNvSpPr txBox="1">
            <a:spLocks/>
          </p:cNvSpPr>
          <p:nvPr/>
        </p:nvSpPr>
        <p:spPr>
          <a:xfrm rot="16200000">
            <a:off x="5959540" y="10456862"/>
            <a:ext cx="3243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/>
              </a:rPr>
              <a:t>%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endParaRPr lang="en-US" sz="2400" baseline="30000" dirty="0">
              <a:latin typeface="Times New Roman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82D3A7F-986F-03EC-B9CE-D9FFB3C62AE3}"/>
              </a:ext>
            </a:extLst>
          </p:cNvPr>
          <p:cNvSpPr txBox="1">
            <a:spLocks/>
          </p:cNvSpPr>
          <p:nvPr/>
        </p:nvSpPr>
        <p:spPr>
          <a:xfrm rot="16200000">
            <a:off x="11618410" y="10456862"/>
            <a:ext cx="3243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/>
              </a:rPr>
              <a:t>%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endParaRPr lang="en-US" sz="2400" baseline="30000" dirty="0">
              <a:latin typeface="Times New Roman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CBBA471-9B01-9692-DB66-014B8854828A}"/>
              </a:ext>
            </a:extLst>
          </p:cNvPr>
          <p:cNvSpPr txBox="1"/>
          <p:nvPr/>
        </p:nvSpPr>
        <p:spPr>
          <a:xfrm>
            <a:off x="1174673" y="9412000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194A981-0B62-2920-E5E9-8DBA89558DE4}"/>
              </a:ext>
            </a:extLst>
          </p:cNvPr>
          <p:cNvSpPr txBox="1"/>
          <p:nvPr/>
        </p:nvSpPr>
        <p:spPr>
          <a:xfrm>
            <a:off x="6729432" y="9426305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2585DF8-A460-5DB6-C7BB-D55990C7E618}"/>
              </a:ext>
            </a:extLst>
          </p:cNvPr>
          <p:cNvSpPr txBox="1"/>
          <p:nvPr/>
        </p:nvSpPr>
        <p:spPr>
          <a:xfrm>
            <a:off x="12317432" y="9426305"/>
            <a:ext cx="6815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F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C8B26B45-06A1-A488-D040-041CC56C40C0}"/>
              </a:ext>
            </a:extLst>
          </p:cNvPr>
          <p:cNvCxnSpPr>
            <a:cxnSpLocks/>
          </p:cNvCxnSpPr>
          <p:nvPr/>
        </p:nvCxnSpPr>
        <p:spPr>
          <a:xfrm>
            <a:off x="4029299" y="101885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D41B60F7-22F2-26DC-1985-E60E802971B5}"/>
              </a:ext>
            </a:extLst>
          </p:cNvPr>
          <p:cNvCxnSpPr>
            <a:cxnSpLocks/>
          </p:cNvCxnSpPr>
          <p:nvPr/>
        </p:nvCxnSpPr>
        <p:spPr>
          <a:xfrm flipH="1">
            <a:off x="4029307" y="10188538"/>
            <a:ext cx="1935160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3BA1EF83-4BF4-8102-C69D-B227BCC106DE}"/>
              </a:ext>
            </a:extLst>
          </p:cNvPr>
          <p:cNvSpPr txBox="1">
            <a:spLocks/>
          </p:cNvSpPr>
          <p:nvPr/>
        </p:nvSpPr>
        <p:spPr>
          <a:xfrm>
            <a:off x="4029302" y="9763164"/>
            <a:ext cx="1935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Times New Roman"/>
              </a:rPr>
              <a:t>**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068B431-A0DE-7747-1B5E-266DCC657602}"/>
              </a:ext>
            </a:extLst>
          </p:cNvPr>
          <p:cNvCxnSpPr>
            <a:cxnSpLocks/>
          </p:cNvCxnSpPr>
          <p:nvPr/>
        </p:nvCxnSpPr>
        <p:spPr>
          <a:xfrm>
            <a:off x="5977159" y="101885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9250CCB3-7827-A8D7-A4D1-AB347578CDD4}"/>
              </a:ext>
            </a:extLst>
          </p:cNvPr>
          <p:cNvCxnSpPr>
            <a:cxnSpLocks/>
          </p:cNvCxnSpPr>
          <p:nvPr/>
        </p:nvCxnSpPr>
        <p:spPr>
          <a:xfrm>
            <a:off x="9464899" y="101885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9DB48F66-B715-CEB7-0FE2-ED08F30EE55A}"/>
              </a:ext>
            </a:extLst>
          </p:cNvPr>
          <p:cNvCxnSpPr>
            <a:cxnSpLocks/>
          </p:cNvCxnSpPr>
          <p:nvPr/>
        </p:nvCxnSpPr>
        <p:spPr>
          <a:xfrm flipH="1">
            <a:off x="9464907" y="10188538"/>
            <a:ext cx="1935160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B0F5CF9-BA75-C3DC-F016-19AA71B07053}"/>
              </a:ext>
            </a:extLst>
          </p:cNvPr>
          <p:cNvSpPr txBox="1">
            <a:spLocks/>
          </p:cNvSpPr>
          <p:nvPr/>
        </p:nvSpPr>
        <p:spPr>
          <a:xfrm>
            <a:off x="9464902" y="9775864"/>
            <a:ext cx="1935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Times New Roman"/>
              </a:rPr>
              <a:t>**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B59B7F9-F364-FC56-F776-8CB1B9EA4EDE}"/>
              </a:ext>
            </a:extLst>
          </p:cNvPr>
          <p:cNvCxnSpPr>
            <a:cxnSpLocks/>
          </p:cNvCxnSpPr>
          <p:nvPr/>
        </p:nvCxnSpPr>
        <p:spPr>
          <a:xfrm>
            <a:off x="11412759" y="101885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0D05E14A-C5AD-4CFF-0F17-D0598F2CE30F}"/>
              </a:ext>
            </a:extLst>
          </p:cNvPr>
          <p:cNvCxnSpPr>
            <a:cxnSpLocks/>
          </p:cNvCxnSpPr>
          <p:nvPr/>
        </p:nvCxnSpPr>
        <p:spPr>
          <a:xfrm>
            <a:off x="15040199" y="101377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7E76D05-3347-4AC7-415B-22D5EF6D3E19}"/>
              </a:ext>
            </a:extLst>
          </p:cNvPr>
          <p:cNvCxnSpPr>
            <a:cxnSpLocks/>
          </p:cNvCxnSpPr>
          <p:nvPr/>
        </p:nvCxnSpPr>
        <p:spPr>
          <a:xfrm flipH="1">
            <a:off x="15040207" y="10137738"/>
            <a:ext cx="1935160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2FCBFEF7-A6CC-CFB7-8566-E54E8DCF9BE6}"/>
              </a:ext>
            </a:extLst>
          </p:cNvPr>
          <p:cNvSpPr txBox="1">
            <a:spLocks/>
          </p:cNvSpPr>
          <p:nvPr/>
        </p:nvSpPr>
        <p:spPr>
          <a:xfrm>
            <a:off x="15040202" y="9712364"/>
            <a:ext cx="1935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Times New Roman"/>
              </a:rPr>
              <a:t>***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22C9FC1A-AB76-C7DD-0706-B31D806F255A}"/>
              </a:ext>
            </a:extLst>
          </p:cNvPr>
          <p:cNvCxnSpPr>
            <a:cxnSpLocks/>
          </p:cNvCxnSpPr>
          <p:nvPr/>
        </p:nvCxnSpPr>
        <p:spPr>
          <a:xfrm>
            <a:off x="16988059" y="10137738"/>
            <a:ext cx="0" cy="2234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C75C3C96-AE04-930D-E274-108B57A5AA24}"/>
              </a:ext>
            </a:extLst>
          </p:cNvPr>
          <p:cNvSpPr txBox="1">
            <a:spLocks/>
          </p:cNvSpPr>
          <p:nvPr/>
        </p:nvSpPr>
        <p:spPr>
          <a:xfrm rot="16200000">
            <a:off x="454889" y="6064100"/>
            <a:ext cx="3243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/>
              </a:rPr>
              <a:t>%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V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C1AD8061-A49F-43E5-933A-0B8806CA81C0}"/>
              </a:ext>
            </a:extLst>
          </p:cNvPr>
          <p:cNvSpPr/>
          <p:nvPr/>
        </p:nvSpPr>
        <p:spPr>
          <a:xfrm>
            <a:off x="2360763" y="16916400"/>
            <a:ext cx="1694603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2400" dirty="0"/>
              <a:t>Naïve CD4⁺ T cells from wild-type or GPR65⁻/⁻ mice were differentiated under Th17 conditions, stained with CFSE, and analyzed by flow cytometry. (S2A–C) Quantification of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V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,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V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, 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AnnexinV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  <a:endParaRPr lang="en-US" sz="2400" dirty="0"/>
          </a:p>
          <a:p>
            <a:r>
              <a:rPr lang="en-US" sz="2400" dirty="0"/>
              <a:t>(S2D–F) Quantification of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US" sz="2400" dirty="0"/>
              <a:t>,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r>
              <a:rPr lang="en-US" sz="2400" dirty="0"/>
              <a:t>, and </a:t>
            </a:r>
            <a:r>
              <a:rPr lang="ca-ES" sz="2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ca-ES" sz="2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 </a:t>
            </a:r>
            <a:r>
              <a:rPr lang="en-US" sz="2400" dirty="0"/>
              <a:t>cells. Data represent mean ± </a:t>
            </a:r>
            <a:r>
              <a:rPr lang="en-US" sz="2400" dirty="0" err="1"/>
              <a:t>s.e.m.</a:t>
            </a:r>
            <a:r>
              <a:rPr lang="en-US" sz="2400" dirty="0"/>
              <a:t>, n = 3 independent experiments. Statistical significance was determined by unpaired Student’s t-test (*P &lt; 0.05; **P &lt; 0.005).Bar graphs represent mean percentage ± </a:t>
            </a:r>
            <a:r>
              <a:rPr lang="en-US" sz="2400" dirty="0" err="1"/>
              <a:t>s.e.m.</a:t>
            </a:r>
            <a:r>
              <a:rPr lang="en-US" sz="2400" dirty="0"/>
              <a:t>, n = 3 independent experiments.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540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98</TotalTime>
  <Words>155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llian Knox</dc:creator>
  <cp:lastModifiedBy>Jeniffer Hernandez</cp:lastModifiedBy>
  <cp:revision>41</cp:revision>
  <cp:lastPrinted>2019-11-07T20:50:19Z</cp:lastPrinted>
  <dcterms:created xsi:type="dcterms:W3CDTF">2019-04-05T15:34:45Z</dcterms:created>
  <dcterms:modified xsi:type="dcterms:W3CDTF">2026-03-27T17:52:31Z</dcterms:modified>
</cp:coreProperties>
</file>